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8" d="100"/>
          <a:sy n="78" d="100"/>
        </p:scale>
        <p:origin x="642" y="-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85D93-4D3F-4235-A14A-2A0DC188279B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5080-FB14-48A2-BB4B-ACC0D68D09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84678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85D93-4D3F-4235-A14A-2A0DC188279B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5080-FB14-48A2-BB4B-ACC0D68D09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569253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85D93-4D3F-4235-A14A-2A0DC188279B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5080-FB14-48A2-BB4B-ACC0D68D09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66547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85D93-4D3F-4235-A14A-2A0DC188279B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5080-FB14-48A2-BB4B-ACC0D68D09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19172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85D93-4D3F-4235-A14A-2A0DC188279B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5080-FB14-48A2-BB4B-ACC0D68D09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2089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85D93-4D3F-4235-A14A-2A0DC188279B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5080-FB14-48A2-BB4B-ACC0D68D09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93061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85D93-4D3F-4235-A14A-2A0DC188279B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5080-FB14-48A2-BB4B-ACC0D68D09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2210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85D93-4D3F-4235-A14A-2A0DC188279B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5080-FB14-48A2-BB4B-ACC0D68D09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62415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85D93-4D3F-4235-A14A-2A0DC188279B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5080-FB14-48A2-BB4B-ACC0D68D09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8151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85D93-4D3F-4235-A14A-2A0DC188279B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5080-FB14-48A2-BB4B-ACC0D68D09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71303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85D93-4D3F-4235-A14A-2A0DC188279B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85080-FB14-48A2-BB4B-ACC0D68D09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042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385D93-4D3F-4235-A14A-2A0DC188279B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C85080-FB14-48A2-BB4B-ACC0D68D094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55078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image" Target="../media/image5.tiff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0" Type="http://schemas.openxmlformats.org/officeDocument/2006/relationships/image" Target="../media/image3.emf"/><Relationship Id="rId4" Type="http://schemas.openxmlformats.org/officeDocument/2006/relationships/image" Target="../media/image6.tiff"/><Relationship Id="rId9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B9C1E168-108A-44F2-AD9B-753CAE1B85CF}"/>
              </a:ext>
            </a:extLst>
          </p:cNvPr>
          <p:cNvSpPr txBox="1"/>
          <p:nvPr/>
        </p:nvSpPr>
        <p:spPr>
          <a:xfrm>
            <a:off x="0" y="2216798"/>
            <a:ext cx="309691" cy="222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4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5CBCDA2E-0C79-4A9F-8911-96E4FFE8802A}"/>
              </a:ext>
            </a:extLst>
          </p:cNvPr>
          <p:cNvSpPr txBox="1"/>
          <p:nvPr/>
        </p:nvSpPr>
        <p:spPr>
          <a:xfrm>
            <a:off x="53445" y="4388095"/>
            <a:ext cx="1064018" cy="222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4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0A080B61-1A22-45CC-B861-F61C96B7AF0D}"/>
              </a:ext>
            </a:extLst>
          </p:cNvPr>
          <p:cNvSpPr txBox="1"/>
          <p:nvPr/>
        </p:nvSpPr>
        <p:spPr>
          <a:xfrm>
            <a:off x="1002351" y="3853628"/>
            <a:ext cx="721391" cy="222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45" dirty="0">
                <a:latin typeface="Arial" panose="020B0604020202020204" pitchFamily="34" charset="0"/>
                <a:cs typeface="Arial" panose="020B0604020202020204" pitchFamily="34" charset="0"/>
              </a:rPr>
              <a:t>p6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EEDFB581-A1EC-4B82-BF0D-0EAA0427EF6F}"/>
              </a:ext>
            </a:extLst>
          </p:cNvPr>
          <p:cNvSpPr txBox="1"/>
          <p:nvPr/>
        </p:nvSpPr>
        <p:spPr>
          <a:xfrm>
            <a:off x="866625" y="6099950"/>
            <a:ext cx="857119" cy="222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45" dirty="0">
                <a:latin typeface="Arial" panose="020B0604020202020204" pitchFamily="34" charset="0"/>
                <a:cs typeface="Arial" panose="020B0604020202020204" pitchFamily="34" charset="0"/>
              </a:rPr>
              <a:t>LC3B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E01AC18A-4BA5-40BE-A120-5881FA83479D}"/>
              </a:ext>
            </a:extLst>
          </p:cNvPr>
          <p:cNvGrpSpPr/>
          <p:nvPr/>
        </p:nvGrpSpPr>
        <p:grpSpPr>
          <a:xfrm>
            <a:off x="210399" y="2421450"/>
            <a:ext cx="2044931" cy="1455089"/>
            <a:chOff x="48319" y="4144102"/>
            <a:chExt cx="1936057" cy="1377619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xmlns="" id="{6B10D0B4-D114-4C1F-A98B-4D97015C11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03" t="84883" r="90263" b="7974"/>
            <a:stretch/>
          </p:blipFill>
          <p:spPr>
            <a:xfrm>
              <a:off x="48319" y="4144102"/>
              <a:ext cx="1936057" cy="1377619"/>
            </a:xfrm>
            <a:prstGeom prst="rect">
              <a:avLst/>
            </a:prstGeom>
          </p:spPr>
        </p:pic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xmlns="" id="{82B84C7C-D450-4F15-84E8-726C3B2A3F42}"/>
                </a:ext>
              </a:extLst>
            </p:cNvPr>
            <p:cNvCxnSpPr/>
            <p:nvPr/>
          </p:nvCxnSpPr>
          <p:spPr>
            <a:xfrm flipV="1">
              <a:off x="798108" y="5059019"/>
              <a:ext cx="55084" cy="0"/>
            </a:xfrm>
            <a:prstGeom prst="straightConnector1">
              <a:avLst/>
            </a:prstGeom>
            <a:ln w="38100">
              <a:solidFill>
                <a:schemeClr val="bg1"/>
              </a:solidFill>
              <a:headEnd type="none" w="lg" len="lg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xmlns="" id="{3FA2EF63-EFA3-4525-ABA4-C7509089DFA6}"/>
                </a:ext>
              </a:extLst>
            </p:cNvPr>
            <p:cNvCxnSpPr/>
            <p:nvPr/>
          </p:nvCxnSpPr>
          <p:spPr>
            <a:xfrm flipV="1">
              <a:off x="333566" y="4748709"/>
              <a:ext cx="55084" cy="0"/>
            </a:xfrm>
            <a:prstGeom prst="straightConnector1">
              <a:avLst/>
            </a:prstGeom>
            <a:ln w="38100">
              <a:solidFill>
                <a:schemeClr val="bg1"/>
              </a:solidFill>
              <a:headEnd type="none" w="lg" len="lg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xmlns="" id="{4D11BE35-4341-46AD-A2C2-6821C2377DEA}"/>
                </a:ext>
              </a:extLst>
            </p:cNvPr>
            <p:cNvCxnSpPr/>
            <p:nvPr/>
          </p:nvCxnSpPr>
          <p:spPr>
            <a:xfrm flipV="1">
              <a:off x="1268162" y="4801956"/>
              <a:ext cx="55084" cy="0"/>
            </a:xfrm>
            <a:prstGeom prst="straightConnector1">
              <a:avLst/>
            </a:prstGeom>
            <a:ln w="38100">
              <a:solidFill>
                <a:schemeClr val="bg1"/>
              </a:solidFill>
              <a:headEnd type="none" w="lg" len="lg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xmlns="" id="{25C233B5-B197-46C6-AE35-7F79168E24DE}"/>
                </a:ext>
              </a:extLst>
            </p:cNvPr>
            <p:cNvSpPr/>
            <p:nvPr/>
          </p:nvSpPr>
          <p:spPr>
            <a:xfrm>
              <a:off x="87836" y="5304035"/>
              <a:ext cx="1005840" cy="17771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45" dirty="0">
                  <a:latin typeface="Arial" panose="020B0604020202020204" pitchFamily="34" charset="0"/>
                  <a:cs typeface="Arial" panose="020B0604020202020204" pitchFamily="34" charset="0"/>
                </a:rPr>
                <a:t>25um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xmlns="" id="{6D570D96-4576-4393-AB48-C9C70A5BDFE8}"/>
              </a:ext>
            </a:extLst>
          </p:cNvPr>
          <p:cNvGrpSpPr/>
          <p:nvPr/>
        </p:nvGrpSpPr>
        <p:grpSpPr>
          <a:xfrm>
            <a:off x="239775" y="4657877"/>
            <a:ext cx="2038687" cy="1472548"/>
            <a:chOff x="42432" y="6683375"/>
            <a:chExt cx="1930146" cy="1394148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xmlns="" id="{02482E5D-7594-4962-A001-A8B5FDEC01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2" t="76899" r="91772" b="15849"/>
            <a:stretch/>
          </p:blipFill>
          <p:spPr>
            <a:xfrm>
              <a:off x="42432" y="6683375"/>
              <a:ext cx="1930146" cy="1394148"/>
            </a:xfrm>
            <a:prstGeom prst="rect">
              <a:avLst/>
            </a:prstGeom>
          </p:spPr>
        </p:pic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xmlns="" id="{96474017-1BD0-4740-9F7F-D952BFFDA56B}"/>
                </a:ext>
              </a:extLst>
            </p:cNvPr>
            <p:cNvCxnSpPr/>
            <p:nvPr/>
          </p:nvCxnSpPr>
          <p:spPr>
            <a:xfrm flipV="1">
              <a:off x="873389" y="7304629"/>
              <a:ext cx="55084" cy="0"/>
            </a:xfrm>
            <a:prstGeom prst="straightConnector1">
              <a:avLst/>
            </a:prstGeom>
            <a:ln w="38100">
              <a:solidFill>
                <a:schemeClr val="bg1"/>
              </a:solidFill>
              <a:headEnd type="none" w="lg" len="lg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xmlns="" id="{68BF5364-0EDF-432A-9EC3-B84FDDFDCE51}"/>
                </a:ext>
              </a:extLst>
            </p:cNvPr>
            <p:cNvCxnSpPr/>
            <p:nvPr/>
          </p:nvCxnSpPr>
          <p:spPr>
            <a:xfrm flipV="1">
              <a:off x="1332426" y="7554339"/>
              <a:ext cx="55084" cy="0"/>
            </a:xfrm>
            <a:prstGeom prst="straightConnector1">
              <a:avLst/>
            </a:prstGeom>
            <a:ln w="38100">
              <a:solidFill>
                <a:schemeClr val="bg1"/>
              </a:solidFill>
              <a:headEnd type="none" w="lg" len="lg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xmlns="" id="{B880542B-F3BD-42C6-B313-6644CE83BB58}"/>
                </a:ext>
              </a:extLst>
            </p:cNvPr>
            <p:cNvSpPr/>
            <p:nvPr/>
          </p:nvSpPr>
          <p:spPr>
            <a:xfrm>
              <a:off x="90892" y="7837028"/>
              <a:ext cx="1005840" cy="17771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45" dirty="0">
                  <a:latin typeface="Arial" panose="020B0604020202020204" pitchFamily="34" charset="0"/>
                  <a:cs typeface="Arial" panose="020B0604020202020204" pitchFamily="34" charset="0"/>
                </a:rPr>
                <a:t>25um</a:t>
              </a:r>
            </a:p>
          </p:txBody>
        </p:sp>
      </p:grpSp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xmlns="" id="{46DDFF14-AA83-48DD-B600-7497C354B0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4233681"/>
              </p:ext>
            </p:extLst>
          </p:nvPr>
        </p:nvGraphicFramePr>
        <p:xfrm>
          <a:off x="4639512" y="2216799"/>
          <a:ext cx="1981945" cy="19417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7" r:id="rId5" imgW="1875722" imgH="1837604" progId="Prism7.Document">
                  <p:embed/>
                </p:oleObj>
              </mc:Choice>
              <mc:Fallback>
                <p:oleObj name="Prism 7" r:id="rId5" imgW="1875722" imgH="183760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39512" y="2216799"/>
                        <a:ext cx="1981945" cy="19417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xmlns="" id="{56C0D327-3DE8-4611-82C8-EB924DC660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2203521"/>
              </p:ext>
            </p:extLst>
          </p:nvPr>
        </p:nvGraphicFramePr>
        <p:xfrm>
          <a:off x="2397287" y="2168784"/>
          <a:ext cx="3018191" cy="19920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7" r:id="rId7" imgW="2857317" imgH="1886559" progId="Prism7.Document">
                  <p:embed/>
                </p:oleObj>
              </mc:Choice>
              <mc:Fallback>
                <p:oleObj name="Prism 7" r:id="rId7" imgW="2857317" imgH="188655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397287" y="2168784"/>
                        <a:ext cx="3018191" cy="19920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xmlns="" id="{77A73DEF-B4BB-49D7-A397-334A0BA629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9744522"/>
              </p:ext>
            </p:extLst>
          </p:nvPr>
        </p:nvGraphicFramePr>
        <p:xfrm>
          <a:off x="4614819" y="4337347"/>
          <a:ext cx="2040633" cy="19534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7" r:id="rId9" imgW="1932235" imgH="1849843" progId="Prism7.Document">
                  <p:embed/>
                </p:oleObj>
              </mc:Choice>
              <mc:Fallback>
                <p:oleObj name="Prism 7" r:id="rId9" imgW="1932235" imgH="1849843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614819" y="4337347"/>
                        <a:ext cx="2040633" cy="19534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xmlns="" id="{7F14688F-714C-40B6-A148-D33B428AA8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00475"/>
              </p:ext>
            </p:extLst>
          </p:nvPr>
        </p:nvGraphicFramePr>
        <p:xfrm>
          <a:off x="2397287" y="4374268"/>
          <a:ext cx="2037278" cy="19366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7" r:id="rId11" imgW="1928995" imgH="1833285" progId="Prism7.Document">
                  <p:embed/>
                </p:oleObj>
              </mc:Choice>
              <mc:Fallback>
                <p:oleObj name="Prism 7" r:id="rId11" imgW="1928995" imgH="183328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397287" y="4374268"/>
                        <a:ext cx="2037278" cy="19366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itle 1">
            <a:extLst>
              <a:ext uri="{FF2B5EF4-FFF2-40B4-BE49-F238E27FC236}">
                <a16:creationId xmlns:a16="http://schemas.microsoft.com/office/drawing/2014/main" xmlns="" id="{08050938-435F-B2B6-E067-A62BB41C0E9D}"/>
              </a:ext>
            </a:extLst>
          </p:cNvPr>
          <p:cNvSpPr txBox="1">
            <a:spLocks/>
          </p:cNvSpPr>
          <p:nvPr/>
        </p:nvSpPr>
        <p:spPr>
          <a:xfrm>
            <a:off x="297498" y="87323"/>
            <a:ext cx="5679229" cy="118323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112" smtClean="0"/>
              <a:t>Supplementary Figure 4: Effect of sirolimus treatment on autophagy markers</a:t>
            </a:r>
            <a:endParaRPr lang="en-US" sz="2112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87EA0D39-9895-19D0-3BC7-5E4FA37BECDD}"/>
              </a:ext>
            </a:extLst>
          </p:cNvPr>
          <p:cNvSpPr txBox="1"/>
          <p:nvPr/>
        </p:nvSpPr>
        <p:spPr>
          <a:xfrm>
            <a:off x="189004" y="6692763"/>
            <a:ext cx="621442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4: Additional markers of mTORC1 activity and autophagy.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0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0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0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HC images and quantification for p62 staining from normal (n=12) and DCIS ducts (n=4). (</a:t>
            </a:r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IHC images and quantification of LC3B staining from normal (n=11) and DCIS ducts (n=6).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ignificance was evaluated by paired t-test. 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cale bar, 20 µm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9361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7</vt:lpstr>
      <vt:lpstr>PowerPoint Presentation</vt:lpstr>
    </vt:vector>
  </TitlesOfParts>
  <Company>HP Inc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nya Suresh</dc:creator>
  <cp:lastModifiedBy>Saranya Suresh</cp:lastModifiedBy>
  <cp:revision>1</cp:revision>
  <dcterms:created xsi:type="dcterms:W3CDTF">2023-10-11T12:46:03Z</dcterms:created>
  <dcterms:modified xsi:type="dcterms:W3CDTF">2023-10-11T12:46:13Z</dcterms:modified>
</cp:coreProperties>
</file>